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83"/>
    <p:restoredTop sz="96327"/>
  </p:normalViewPr>
  <p:slideViewPr>
    <p:cSldViewPr snapToGrid="0">
      <p:cViewPr varScale="1">
        <p:scale>
          <a:sx n="128" d="100"/>
          <a:sy n="128" d="100"/>
        </p:scale>
        <p:origin x="5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FE97C-D6E4-3292-B938-BAC0E6E60F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35494C-0E2D-7172-918D-1B1E556050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979D7A-F4FE-6992-B3DD-D584004E3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D503D5-05AC-1A79-6CFC-1CA90D1F5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23A2A2-BE73-3A78-4C79-781018ADA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07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981E6-4028-D357-991D-3FB635D5D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1A23E9-9A03-03F5-3FD1-D21F848F75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365344-4424-39C7-9382-4CD5DC70A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BF894A-F1F2-56E3-5DB5-C4448696A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725133-9237-6647-13B7-69B4059E1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958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1FF3CD-7C78-7AAF-B01D-7AB4FFCFFB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2B9CCB-36C8-D426-1D74-520B4A4813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9FD496-0282-ED8B-67E8-A01F1A941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656A2-D0EA-D225-FAC0-4AD6AAA73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2CC118-C2B2-A945-5E5B-DA262A4A0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35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A0436-FC27-F08C-EC04-58DDA1657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A57AB4-7910-B922-CD65-6AE3EABB9A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800EC-355F-AB08-23D8-B80ACCB2C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2562AE-DC1E-F5B9-9F7F-7125D8DDA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6A2AB3-484A-1F23-05E3-CBE09D0BB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633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1A28E-E057-6847-E6C1-00E1289BA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F5BFA3-BD6A-66C0-00C4-14E56E8EB1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0FF725-F80F-F43E-F2A8-97758BDBA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B48452-C1FA-3846-A223-598A9DC78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A5065D-1AED-31AE-1E1C-9ECDE2E53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6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D0E9D9-CDD9-0E8A-8D2A-58D6F6D53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AB7448-8364-F435-2D6C-6B0B0E5C03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CA0313-D8EA-D852-A75F-9C455FAAC7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71FC20-3578-9619-9A2B-E3CE6F506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AB20EA-D4B5-FFBF-C3AD-EEE42FC26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EE5248-523D-EE82-9271-C5F3AE9D9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662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B2B3E-0652-6DD5-EFB9-9060386384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D2C598-E85E-6CAE-D7C3-27F0FE3D4C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D3E09D-0F6C-0758-0403-90DB4328A2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38CA61-6997-69C1-94C5-590618D742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98867C-9E07-5AE1-D6A1-BFB841C7D0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E3AF04-00B0-B166-8799-AF8421288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49FEEB-8A28-3146-C368-F069BEEE9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87261C-50FC-A6AB-DB4E-105399605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533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6F323-33A3-CE7C-EF67-04AF92EDE9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DAD672-E998-2417-0355-7E68EC1C0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0C2AB7-D760-7415-968B-68085126C3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77FF46-DECC-BC34-5B08-2003DC9CA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449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9BCFFD-9280-AEA4-2FCF-0AA132228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3AA3E5-748E-4C9E-F72D-DBEE88E3E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5DBDEA-E5DD-4EB3-B871-C05DCB4E5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078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241C17-A696-209E-941C-A1AF340E4E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5926BE-9FE5-3C3C-C482-0DFC22CBFF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3FFFF1-F623-309D-4E16-565CE74F6F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E78213-4C44-E8B6-E95E-B0F0615FC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3C17A3-DA89-B84E-F0AF-A7C71749D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846B98-3B03-59D4-0EA9-6A332CEB8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726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B6C0CF-1F90-DF39-AF1A-BCE0B6D63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3511D9-B579-AFDD-2012-F91018D7F2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0D1BC3-50EA-3F34-68D1-84BE418AB6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FAAE34-FC76-6817-A131-82C5468E7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6ABAFE-695B-F486-ABBB-16A17F291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FB0CA4-DAF8-DF9A-EE5F-8495075D9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727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9F8879-1168-75A0-8583-C659F08F2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21EAED-70F8-0B65-90D8-9C17912996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0F278C-04BF-FB62-A26D-B53F64C679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4A04EE-E9B1-684A-B256-C57AB0F68670}" type="datetimeFigureOut">
              <a:rPr lang="en-US" smtClean="0"/>
              <a:t>3/1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1B8DF4-F220-2851-D394-D817718F94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56202-0A78-A9DD-EC2F-8BCD0733BC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CC3EE7-B771-D845-A69A-0B96E898B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494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1EAD2176-2741-B9F8-F611-A25B8F8DC6E3}"/>
              </a:ext>
            </a:extLst>
          </p:cNvPr>
          <p:cNvSpPr txBox="1"/>
          <p:nvPr/>
        </p:nvSpPr>
        <p:spPr>
          <a:xfrm>
            <a:off x="0" y="6488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20B1FED-F9AE-96E7-7082-FE84767D1279}"/>
              </a:ext>
            </a:extLst>
          </p:cNvPr>
          <p:cNvSpPr txBox="1"/>
          <p:nvPr/>
        </p:nvSpPr>
        <p:spPr>
          <a:xfrm>
            <a:off x="1996055" y="4118824"/>
            <a:ext cx="8372168" cy="14490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BMCs were purified as described in Materials and Methods. The different subsets were defined based on the expression levels of CD14 and CD16: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classical monocytes =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CD1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high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CD16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low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 (R2), intermediate monocytes = CD1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high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CD16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high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(R3) and non-classical monocytes = CD1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low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CD16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high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 (R4). To determine the percentages of the different subsets, the sum of the three subsets was considered to be the entire monocyte population (=100%) and the different percentages were determined from this total population. </a:t>
            </a:r>
            <a:endParaRPr lang="en-US" sz="1200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3E9ED86A-04EC-A014-148B-FB88A69D0988}"/>
              </a:ext>
            </a:extLst>
          </p:cNvPr>
          <p:cNvGrpSpPr/>
          <p:nvPr/>
        </p:nvGrpSpPr>
        <p:grpSpPr>
          <a:xfrm>
            <a:off x="4492486" y="432352"/>
            <a:ext cx="2842592" cy="2996649"/>
            <a:chOff x="4492486" y="432352"/>
            <a:chExt cx="2842592" cy="2996649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9E56487-7685-AD66-9CC4-11B16E1B43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</a:extLst>
            </a:blip>
            <a:srcRect l="2941" t="7177" r="11739" b="13415"/>
            <a:stretch/>
          </p:blipFill>
          <p:spPr>
            <a:xfrm>
              <a:off x="4572000" y="675861"/>
              <a:ext cx="2763078" cy="2753140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465F5853-36D9-5E29-2EB2-EFD4716A5549}"/>
                </a:ext>
              </a:extLst>
            </p:cNvPr>
            <p:cNvSpPr/>
            <p:nvPr/>
          </p:nvSpPr>
          <p:spPr>
            <a:xfrm>
              <a:off x="4949687" y="561560"/>
              <a:ext cx="1232452" cy="2435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0345DA4F-281F-D318-FDB8-450D341BB09F}"/>
                </a:ext>
              </a:extLst>
            </p:cNvPr>
            <p:cNvSpPr/>
            <p:nvPr/>
          </p:nvSpPr>
          <p:spPr>
            <a:xfrm>
              <a:off x="4492486" y="432352"/>
              <a:ext cx="268357" cy="2435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0B461A72-3059-4345-7561-CDF21858D521}"/>
              </a:ext>
            </a:extLst>
          </p:cNvPr>
          <p:cNvSpPr txBox="1"/>
          <p:nvPr/>
        </p:nvSpPr>
        <p:spPr>
          <a:xfrm>
            <a:off x="5774437" y="3235525"/>
            <a:ext cx="64312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5C9AD91-86EA-79C2-803F-5E0341FC4A24}"/>
              </a:ext>
            </a:extLst>
          </p:cNvPr>
          <p:cNvSpPr txBox="1"/>
          <p:nvPr/>
        </p:nvSpPr>
        <p:spPr>
          <a:xfrm rot="16200000">
            <a:off x="4324812" y="1938468"/>
            <a:ext cx="64312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</a:p>
        </p:txBody>
      </p:sp>
    </p:spTree>
    <p:extLst>
      <p:ext uri="{BB962C8B-B14F-4D97-AF65-F5344CB8AC3E}">
        <p14:creationId xmlns:p14="http://schemas.microsoft.com/office/powerpoint/2010/main" val="141888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6</TotalTime>
  <Words>88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opf, Pascale</dc:creator>
  <cp:lastModifiedBy>Kropf, Pascale</cp:lastModifiedBy>
  <cp:revision>6</cp:revision>
  <dcterms:created xsi:type="dcterms:W3CDTF">2024-03-06T11:50:42Z</dcterms:created>
  <dcterms:modified xsi:type="dcterms:W3CDTF">2024-03-18T10:21:39Z</dcterms:modified>
</cp:coreProperties>
</file>